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nb-NO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03" d="100"/>
          <a:sy n="103" d="100"/>
        </p:scale>
        <p:origin x="126" y="2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E94C53C-41AD-428D-920C-B698E7DC6A4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E18BFE4-0116-477C-A422-57B8995D175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nb-NO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E60F0CB-26A9-4440-B3DA-F918F6E890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830315-3BD2-415C-9FD7-C6544CCDAA17}" type="datetimeFigureOut">
              <a:rPr lang="nb-NO" smtClean="0"/>
              <a:t>17.02.2021</a:t>
            </a:fld>
            <a:endParaRPr lang="nb-NO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3A37E90-2897-47DE-BD89-A82B2C17EC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5C89B1B-54CD-45D9-8CAB-7CFDF0C635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2FF5FE-E510-4D46-ABBF-5DD06BEF98D3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40807706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A7BAD48-DD74-424D-9B33-713A08734DE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72BE6DC-3AA9-4CA7-BAE4-C435288F930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B61EA1E-675D-4914-9ECB-E9A608D5B6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830315-3BD2-415C-9FD7-C6544CCDAA17}" type="datetimeFigureOut">
              <a:rPr lang="nb-NO" smtClean="0"/>
              <a:t>17.02.2021</a:t>
            </a:fld>
            <a:endParaRPr lang="nb-NO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53D7005-FFD1-43BA-AA7E-EB4FD34D60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6058FDB-2B18-4926-89B9-C21901BEB2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2FF5FE-E510-4D46-ABBF-5DD06BEF98D3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1854035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22AC4B9-E994-4777-A992-81B5D9931F6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07BCEC1-EDD3-482B-8DDC-FCC2F69B764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A014789-F597-4432-92F4-4C8028357D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830315-3BD2-415C-9FD7-C6544CCDAA17}" type="datetimeFigureOut">
              <a:rPr lang="nb-NO" smtClean="0"/>
              <a:t>17.02.2021</a:t>
            </a:fld>
            <a:endParaRPr lang="nb-NO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3AAD8F4-0F2F-4DE0-8F1A-2A4CF441D6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7C71D20-C5ED-4FA3-AD2A-71BF0D2651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2FF5FE-E510-4D46-ABBF-5DD06BEF98D3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5795355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983778E-30A8-462C-90F6-57BA73C1673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8364E55-9A86-4233-A6D3-49BE1716746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BC0B47F-5CDD-4D37-A974-4F8E08A863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830315-3BD2-415C-9FD7-C6544CCDAA17}" type="datetimeFigureOut">
              <a:rPr lang="nb-NO" smtClean="0"/>
              <a:t>17.02.2021</a:t>
            </a:fld>
            <a:endParaRPr lang="nb-NO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BAFAAB2-3E6D-4BD5-986A-E215B2C169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DAFF97E-901F-4CA8-9B8B-3AF19702B5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2FF5FE-E510-4D46-ABBF-5DD06BEF98D3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0977965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EBE732-795F-40AC-A3B9-C6A37F35B83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55DAB75-5283-4756-9A0C-BBA24A23153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485FDFD-7567-47FD-B202-AF6470E50A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830315-3BD2-415C-9FD7-C6544CCDAA17}" type="datetimeFigureOut">
              <a:rPr lang="nb-NO" smtClean="0"/>
              <a:t>17.02.2021</a:t>
            </a:fld>
            <a:endParaRPr lang="nb-NO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31DA8DC-0110-4A67-8C63-6679B82FFD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96C0F59-CD63-4D8A-8034-3FBBAB3D78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2FF5FE-E510-4D46-ABBF-5DD06BEF98D3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7414716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E9F6C1E-6835-4919-8E89-EBD069A0DB3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AF64DD7-DEB0-488C-BB58-711084CC0ED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71126E6-2228-46B2-8BD3-1FDE3BDE508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0D70D1A-8E4D-4B1A-AEBD-F4DAC3C0B6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830315-3BD2-415C-9FD7-C6544CCDAA17}" type="datetimeFigureOut">
              <a:rPr lang="nb-NO" smtClean="0"/>
              <a:t>17.02.2021</a:t>
            </a:fld>
            <a:endParaRPr lang="nb-NO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9E29E56-3572-4EB1-8BCF-59E1697513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219C1F1-C405-4FC5-98ED-C4940EF05E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2FF5FE-E510-4D46-ABBF-5DD06BEF98D3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4880018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F5FE1C8-A410-425F-A86A-02ADEBFFE38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09C9A90-E30F-4602-B212-F777ADEAB44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20E539D-5568-42C6-95DD-1843868EAA6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4C91649-65E1-4ACA-BCB6-94F6337EF5E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2064AAC-A799-49B5-8CA3-1D8D86E1C8F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54A05A3-C9DA-425C-B8FE-30B339093D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830315-3BD2-415C-9FD7-C6544CCDAA17}" type="datetimeFigureOut">
              <a:rPr lang="nb-NO" smtClean="0"/>
              <a:t>17.02.2021</a:t>
            </a:fld>
            <a:endParaRPr lang="nb-NO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8676F48-5173-42B8-B231-BDE620CB98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30EC292-02C6-46A2-80BF-07BC0475CD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2FF5FE-E510-4D46-ABBF-5DD06BEF98D3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40144431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390DAE2-F318-4E7D-9197-7CD5850A4A9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3016612-DC80-4AF5-A044-1A77FCCEBA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830315-3BD2-415C-9FD7-C6544CCDAA17}" type="datetimeFigureOut">
              <a:rPr lang="nb-NO" smtClean="0"/>
              <a:t>17.02.2021</a:t>
            </a:fld>
            <a:endParaRPr lang="nb-NO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8718C03-E724-4A92-AE6A-90273D65DE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965FCC5-F23F-46EC-9A7D-8C795351B5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2FF5FE-E510-4D46-ABBF-5DD06BEF98D3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6608578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2A451F7-4033-4E1C-80AE-374AFF04E8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830315-3BD2-415C-9FD7-C6544CCDAA17}" type="datetimeFigureOut">
              <a:rPr lang="nb-NO" smtClean="0"/>
              <a:t>17.02.2021</a:t>
            </a:fld>
            <a:endParaRPr lang="nb-NO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B9B1C03-AE52-4E24-AE52-85B19CCD68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23C2D57-7A69-46CD-A57D-2BF757985B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2FF5FE-E510-4D46-ABBF-5DD06BEF98D3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888881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5F5DB2B-D3FE-4407-AC31-81E92E882D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F30F802-1776-4934-AA59-DC5C8E4E5A9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4D1C274-C7F9-45EE-824E-36E61761B9A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4B02B71-5BEB-43B8-AEEC-BE303C1938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830315-3BD2-415C-9FD7-C6544CCDAA17}" type="datetimeFigureOut">
              <a:rPr lang="nb-NO" smtClean="0"/>
              <a:t>17.02.2021</a:t>
            </a:fld>
            <a:endParaRPr lang="nb-NO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750F42C-3BB3-4259-956A-F4E4462A14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CEE3265-6152-4E34-BD07-41C980F2F6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2FF5FE-E510-4D46-ABBF-5DD06BEF98D3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4685150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17BF01D-90F8-44EF-AC61-9D9930A210F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C415E02-DD8F-4FB3-B48B-CD06675C17F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b-NO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6B1BFA8-1E35-4C20-A189-ECDEFC6785E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D48AC31-3DE8-47BA-9F71-40CF70D038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830315-3BD2-415C-9FD7-C6544CCDAA17}" type="datetimeFigureOut">
              <a:rPr lang="nb-NO" smtClean="0"/>
              <a:t>17.02.2021</a:t>
            </a:fld>
            <a:endParaRPr lang="nb-NO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F5EF74E-8419-4D7F-A5DB-F1762CCB00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DCC9397-51CF-4E02-9D5A-011FF910A3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2FF5FE-E510-4D46-ABBF-5DD06BEF98D3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8657181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A09DF00-55F3-4876-8C7C-18335877568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7AC1D50-865A-474D-B88C-5BBDDD86030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997ABC5-8587-4E63-9267-14BAFF255CA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830315-3BD2-415C-9FD7-C6544CCDAA17}" type="datetimeFigureOut">
              <a:rPr lang="nb-NO" smtClean="0"/>
              <a:t>17.02.2021</a:t>
            </a:fld>
            <a:endParaRPr lang="nb-NO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703D245-D5DA-4127-AF51-9050B4A2530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b-NO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5B17F6B-01AD-4CB6-8D8F-EEEA2B232D2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2FF5FE-E510-4D46-ABBF-5DD06BEF98D3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1817637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b-NO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4BBC3D53-7E2F-42CE-A62C-724047721FAE}"/>
              </a:ext>
            </a:extLst>
          </p:cNvPr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11996" y="155463"/>
            <a:ext cx="6350000" cy="4637405"/>
          </a:xfrm>
          <a:prstGeom prst="rect">
            <a:avLst/>
          </a:prstGeom>
          <a:noFill/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id="{2E2D7DF1-0DD6-4F37-A203-46FE74334199}"/>
              </a:ext>
            </a:extLst>
          </p:cNvPr>
          <p:cNvSpPr/>
          <p:nvPr/>
        </p:nvSpPr>
        <p:spPr>
          <a:xfrm>
            <a:off x="2965996" y="5132877"/>
            <a:ext cx="6096000" cy="1569660"/>
          </a:xfrm>
          <a:prstGeom prst="rect">
            <a:avLst/>
          </a:prstGeom>
        </p:spPr>
        <p:txBody>
          <a:bodyPr>
            <a:spAutoFit/>
          </a:bodyPr>
          <a:lstStyle/>
          <a:p>
            <a:pPr>
              <a:spcBef>
                <a:spcPts val="600"/>
              </a:spcBef>
              <a:spcAft>
                <a:spcPts val="1200"/>
              </a:spcAft>
            </a:pP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S1.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Schematic illustrations of dot matrix views showing highly similar regions between 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A)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933W and Eru1 phage TL-2011c, 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B)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Eru2 of </a:t>
            </a:r>
            <a:r>
              <a:rPr lang="en-US" sz="12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. coli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TW14359 and Eru3 of </a:t>
            </a:r>
            <a:r>
              <a:rPr lang="en-US" sz="12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. coli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F8952, 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C)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Eru1 (TL-2011c) and Eru2 (TW14359) and 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D)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Eru1 (TL-2011c) and Eru3 (F8952). The alignments are based upon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LASTn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lgorithm and are shown in the plot as lines. The query sequence is represented on the X-axis and the subject sequence is represented on the Y-axis. The numbers on the X and Y axis represent the bases of the query and subject sequence, respectively. Plus-strand matches are slanted from the bottom left to the upper right corner. The position of the replication regions of the phages are indicated by red circles.</a:t>
            </a:r>
            <a:endParaRPr lang="nb-NO" sz="12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6764497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49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oril Lindbäck</dc:creator>
  <cp:lastModifiedBy>Toril Lindbäck</cp:lastModifiedBy>
  <cp:revision>1</cp:revision>
  <dcterms:created xsi:type="dcterms:W3CDTF">2021-02-17T12:52:01Z</dcterms:created>
  <dcterms:modified xsi:type="dcterms:W3CDTF">2021-02-17T12:53:2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d0484126-3486-41a9-802e-7f1e2277276c_Enabled">
    <vt:lpwstr>True</vt:lpwstr>
  </property>
  <property fmtid="{D5CDD505-2E9C-101B-9397-08002B2CF9AE}" pid="3" name="MSIP_Label_d0484126-3486-41a9-802e-7f1e2277276c_SiteId">
    <vt:lpwstr>eec01f8e-737f-43e3-9ed5-f8a59913bd82</vt:lpwstr>
  </property>
  <property fmtid="{D5CDD505-2E9C-101B-9397-08002B2CF9AE}" pid="4" name="MSIP_Label_d0484126-3486-41a9-802e-7f1e2277276c_Owner">
    <vt:lpwstr>toril.lindback@nmbu.no</vt:lpwstr>
  </property>
  <property fmtid="{D5CDD505-2E9C-101B-9397-08002B2CF9AE}" pid="5" name="MSIP_Label_d0484126-3486-41a9-802e-7f1e2277276c_SetDate">
    <vt:lpwstr>2021-02-17T12:53:24.6011290Z</vt:lpwstr>
  </property>
  <property fmtid="{D5CDD505-2E9C-101B-9397-08002B2CF9AE}" pid="6" name="MSIP_Label_d0484126-3486-41a9-802e-7f1e2277276c_Name">
    <vt:lpwstr>Internal</vt:lpwstr>
  </property>
  <property fmtid="{D5CDD505-2E9C-101B-9397-08002B2CF9AE}" pid="7" name="MSIP_Label_d0484126-3486-41a9-802e-7f1e2277276c_Application">
    <vt:lpwstr>Microsoft Azure Information Protection</vt:lpwstr>
  </property>
  <property fmtid="{D5CDD505-2E9C-101B-9397-08002B2CF9AE}" pid="8" name="MSIP_Label_d0484126-3486-41a9-802e-7f1e2277276c_ActionId">
    <vt:lpwstr>9e9a3a34-1c9b-4f39-9575-69be7950713a</vt:lpwstr>
  </property>
  <property fmtid="{D5CDD505-2E9C-101B-9397-08002B2CF9AE}" pid="9" name="MSIP_Label_d0484126-3486-41a9-802e-7f1e2277276c_Extended_MSFT_Method">
    <vt:lpwstr>Automatic</vt:lpwstr>
  </property>
  <property fmtid="{D5CDD505-2E9C-101B-9397-08002B2CF9AE}" pid="10" name="Sensitivity">
    <vt:lpwstr>Internal</vt:lpwstr>
  </property>
</Properties>
</file>